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4" r:id="rId2"/>
    <p:sldId id="257" r:id="rId3"/>
    <p:sldId id="258" r:id="rId4"/>
    <p:sldId id="259" r:id="rId5"/>
    <p:sldId id="260" r:id="rId6"/>
    <p:sldId id="261" r:id="rId7"/>
    <p:sldId id="263" r:id="rId8"/>
    <p:sldId id="287" r:id="rId9"/>
    <p:sldId id="264" r:id="rId10"/>
    <p:sldId id="266" r:id="rId11"/>
    <p:sldId id="267" r:id="rId12"/>
    <p:sldId id="270" r:id="rId13"/>
    <p:sldId id="273" r:id="rId14"/>
    <p:sldId id="275" r:id="rId15"/>
    <p:sldId id="276" r:id="rId16"/>
    <p:sldId id="277" r:id="rId17"/>
    <p:sldId id="285" r:id="rId18"/>
    <p:sldId id="278" r:id="rId19"/>
    <p:sldId id="280" r:id="rId20"/>
    <p:sldId id="282" r:id="rId21"/>
    <p:sldId id="283" r:id="rId22"/>
    <p:sldId id="286" r:id="rId2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0912E78-BF04-4481-AD76-7BEEE90A88EF}" v="7" dt="2022-10-06T20:38:39.83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98" d="100"/>
          <a:sy n="98" d="100"/>
        </p:scale>
        <p:origin x="90" y="4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microsoft.com/office/2016/11/relationships/changesInfo" Target="changesInfos/changesInfo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wensen, Adam C" userId="b8ada73e-8961-428f-a159-7a70309f0263" providerId="ADAL" clId="{F0912E78-BF04-4481-AD76-7BEEE90A88EF}"/>
    <pc:docChg chg="custSel modSld">
      <pc:chgData name="Swensen, Adam C" userId="b8ada73e-8961-428f-a159-7a70309f0263" providerId="ADAL" clId="{F0912E78-BF04-4481-AD76-7BEEE90A88EF}" dt="2022-10-06T20:38:42.655" v="32" actId="14100"/>
      <pc:docMkLst>
        <pc:docMk/>
      </pc:docMkLst>
      <pc:sldChg chg="addSp delSp modSp mod">
        <pc:chgData name="Swensen, Adam C" userId="b8ada73e-8961-428f-a159-7a70309f0263" providerId="ADAL" clId="{F0912E78-BF04-4481-AD76-7BEEE90A88EF}" dt="2022-10-06T20:38:42.655" v="32" actId="14100"/>
        <pc:sldMkLst>
          <pc:docMk/>
          <pc:sldMk cId="3971974569" sldId="258"/>
        </pc:sldMkLst>
        <pc:picChg chg="add del mod">
          <ac:chgData name="Swensen, Adam C" userId="b8ada73e-8961-428f-a159-7a70309f0263" providerId="ADAL" clId="{F0912E78-BF04-4481-AD76-7BEEE90A88EF}" dt="2022-10-06T18:15:10.468" v="16" actId="478"/>
          <ac:picMkLst>
            <pc:docMk/>
            <pc:sldMk cId="3971974569" sldId="258"/>
            <ac:picMk id="2" creationId="{193A93B2-9CEA-499B-8E1F-AC1DC055ED72}"/>
          </ac:picMkLst>
        </pc:picChg>
        <pc:picChg chg="add del mod">
          <ac:chgData name="Swensen, Adam C" userId="b8ada73e-8961-428f-a159-7a70309f0263" providerId="ADAL" clId="{F0912E78-BF04-4481-AD76-7BEEE90A88EF}" dt="2022-10-06T18:16:16.156" v="20" actId="478"/>
          <ac:picMkLst>
            <pc:docMk/>
            <pc:sldMk cId="3971974569" sldId="258"/>
            <ac:picMk id="3" creationId="{66A8C3B9-B29D-4155-9633-912C051FE037}"/>
          </ac:picMkLst>
        </pc:picChg>
        <pc:picChg chg="add del mod">
          <ac:chgData name="Swensen, Adam C" userId="b8ada73e-8961-428f-a159-7a70309f0263" providerId="ADAL" clId="{F0912E78-BF04-4481-AD76-7BEEE90A88EF}" dt="2022-10-06T19:31:59.917" v="23" actId="478"/>
          <ac:picMkLst>
            <pc:docMk/>
            <pc:sldMk cId="3971974569" sldId="258"/>
            <ac:picMk id="4" creationId="{DD8BA149-CE9E-4E87-9975-392EE5B9B3AC}"/>
          </ac:picMkLst>
        </pc:picChg>
        <pc:picChg chg="add del mod">
          <ac:chgData name="Swensen, Adam C" userId="b8ada73e-8961-428f-a159-7a70309f0263" providerId="ADAL" clId="{F0912E78-BF04-4481-AD76-7BEEE90A88EF}" dt="2022-10-06T20:32:51.479" v="30" actId="478"/>
          <ac:picMkLst>
            <pc:docMk/>
            <pc:sldMk cId="3971974569" sldId="258"/>
            <ac:picMk id="5" creationId="{72498DB3-7A2C-443D-9BC8-1BC25CB2F735}"/>
          </ac:picMkLst>
        </pc:picChg>
        <pc:picChg chg="add mod">
          <ac:chgData name="Swensen, Adam C" userId="b8ada73e-8961-428f-a159-7a70309f0263" providerId="ADAL" clId="{F0912E78-BF04-4481-AD76-7BEEE90A88EF}" dt="2022-10-06T20:38:42.655" v="32" actId="14100"/>
          <ac:picMkLst>
            <pc:docMk/>
            <pc:sldMk cId="3971974569" sldId="258"/>
            <ac:picMk id="7" creationId="{A6ADAB41-F090-4323-BBCC-660D64067A3B}"/>
          </ac:picMkLst>
        </pc:picChg>
      </pc:sldChg>
      <pc:sldChg chg="addSp modSp mod">
        <pc:chgData name="Swensen, Adam C" userId="b8ada73e-8961-428f-a159-7a70309f0263" providerId="ADAL" clId="{F0912E78-BF04-4481-AD76-7BEEE90A88EF}" dt="2022-10-06T20:31:54.399" v="29" actId="14100"/>
        <pc:sldMkLst>
          <pc:docMk/>
          <pc:sldMk cId="3948125023" sldId="275"/>
        </pc:sldMkLst>
        <pc:picChg chg="add mod">
          <ac:chgData name="Swensen, Adam C" userId="b8ada73e-8961-428f-a159-7a70309f0263" providerId="ADAL" clId="{F0912E78-BF04-4481-AD76-7BEEE90A88EF}" dt="2022-10-06T20:31:54.399" v="29" actId="14100"/>
          <ac:picMkLst>
            <pc:docMk/>
            <pc:sldMk cId="3948125023" sldId="275"/>
            <ac:picMk id="2" creationId="{BA9BF887-33FC-481E-9EF6-C988457DAF67}"/>
          </ac:picMkLst>
        </pc:picChg>
      </pc:sldChg>
      <pc:sldChg chg="addSp modSp mod">
        <pc:chgData name="Swensen, Adam C" userId="b8ada73e-8961-428f-a159-7a70309f0263" providerId="ADAL" clId="{F0912E78-BF04-4481-AD76-7BEEE90A88EF}" dt="2022-10-04T00:27:50.359" v="12" actId="14100"/>
        <pc:sldMkLst>
          <pc:docMk/>
          <pc:sldMk cId="148654812" sldId="282"/>
        </pc:sldMkLst>
        <pc:picChg chg="add mod">
          <ac:chgData name="Swensen, Adam C" userId="b8ada73e-8961-428f-a159-7a70309f0263" providerId="ADAL" clId="{F0912E78-BF04-4481-AD76-7BEEE90A88EF}" dt="2022-10-04T00:27:50.359" v="12" actId="14100"/>
          <ac:picMkLst>
            <pc:docMk/>
            <pc:sldMk cId="148654812" sldId="282"/>
            <ac:picMk id="3" creationId="{11A78D57-EFF6-47A4-A860-BFD903F4A494}"/>
          </ac:picMkLst>
        </pc:picChg>
      </pc:sldChg>
      <pc:sldChg chg="addSp delSp modSp mod">
        <pc:chgData name="Swensen, Adam C" userId="b8ada73e-8961-428f-a159-7a70309f0263" providerId="ADAL" clId="{F0912E78-BF04-4481-AD76-7BEEE90A88EF}" dt="2022-09-30T22:33:29.190" v="10" actId="14100"/>
        <pc:sldMkLst>
          <pc:docMk/>
          <pc:sldMk cId="4165743980" sldId="287"/>
        </pc:sldMkLst>
        <pc:spChg chg="mod">
          <ac:chgData name="Swensen, Adam C" userId="b8ada73e-8961-428f-a159-7a70309f0263" providerId="ADAL" clId="{F0912E78-BF04-4481-AD76-7BEEE90A88EF}" dt="2022-09-30T22:30:30.142" v="7" actId="20577"/>
          <ac:spMkLst>
            <pc:docMk/>
            <pc:sldMk cId="4165743980" sldId="287"/>
            <ac:spMk id="6" creationId="{A592BBA4-1558-4555-9DCA-54CD20968B4B}"/>
          </ac:spMkLst>
        </pc:spChg>
        <pc:picChg chg="del">
          <ac:chgData name="Swensen, Adam C" userId="b8ada73e-8961-428f-a159-7a70309f0263" providerId="ADAL" clId="{F0912E78-BF04-4481-AD76-7BEEE90A88EF}" dt="2022-09-30T22:30:31.925" v="8" actId="478"/>
          <ac:picMkLst>
            <pc:docMk/>
            <pc:sldMk cId="4165743980" sldId="287"/>
            <ac:picMk id="3" creationId="{667F34DC-D1DF-4D9B-BB5C-7118D8623286}"/>
          </ac:picMkLst>
        </pc:picChg>
        <pc:picChg chg="add mod">
          <ac:chgData name="Swensen, Adam C" userId="b8ada73e-8961-428f-a159-7a70309f0263" providerId="ADAL" clId="{F0912E78-BF04-4481-AD76-7BEEE90A88EF}" dt="2022-09-30T22:33:29.190" v="10" actId="14100"/>
          <ac:picMkLst>
            <pc:docMk/>
            <pc:sldMk cId="4165743980" sldId="287"/>
            <ac:picMk id="4" creationId="{FA7A34A0-ABD4-4936-B48F-2F8A912FC4B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9A2CC7-254D-4CA8-B550-088D2941AC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3E9FA2C-0003-4934-B292-42FB8E86AA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3E4F56-5AFF-451E-A6B5-F53F206797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8D52-D88B-414D-B4F2-F08209A96F9E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2E51D5-C7C6-4E9A-871F-CEA86C424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EBD223-61B0-4E44-A0D4-0969CCE35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129E9-23A9-4694-94F4-52B9D8789D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392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D551C1-2C79-42C0-96CD-D78F7FBAD9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38F1B36-AFC1-444D-A5F6-F586453A38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0AA10D-17B0-452F-A4C8-850B880F1F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8D52-D88B-414D-B4F2-F08209A96F9E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A8EA2C-57F2-44E5-A224-C7A2D1811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7324F1-6AD4-4FF2-98FF-4A0CC4501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129E9-23A9-4694-94F4-52B9D8789D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444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2A0180D-077A-4A7C-BFC7-0E65E344AD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315792-7882-4F56-B157-66568C0BA3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048836-86AF-4F73-8483-6156A5987B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8D52-D88B-414D-B4F2-F08209A96F9E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4D2813-B0CA-47AB-9C00-FD31EDA1B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D91288-1DB3-4EAC-BDEA-C894637C8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129E9-23A9-4694-94F4-52B9D8789D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7995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B4D915-D7EA-4F62-B342-3AB5DF5EE5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B9959C-0E37-4C5C-B2DD-26FB35DAF48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738E65-A522-4799-9BA4-5F86994B9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8D52-D88B-414D-B4F2-F08209A96F9E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9339DC-8B6F-47B3-8AC0-472991D212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F073E3-04E8-4B04-A806-2CB328DA57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129E9-23A9-4694-94F4-52B9D8789D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3225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0A1648-A771-41E1-ADB6-D972E4A975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E3464A-CB71-4BD8-9709-068D892BE5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DFDE56-1583-4C20-A108-00BD70C90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8D52-D88B-414D-B4F2-F08209A96F9E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8730D9-8CB9-4557-AB66-09ECBADEF1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E9B8C0-4A7A-4F36-B682-EED4628B41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129E9-23A9-4694-94F4-52B9D8789D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052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79D63E-2614-42F2-8989-2F20647697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B398C5-17A0-4299-9E09-579F6D080A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E082DC-9D0F-44A8-9B0B-185EC168F7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EBF16D-034A-4CD2-BA09-AA506718B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8D52-D88B-414D-B4F2-F08209A96F9E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BED1FC-5206-445A-8CDB-CB584E933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C64005-A981-49AD-ADDA-7E0120B2F4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129E9-23A9-4694-94F4-52B9D8789D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7592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5EB4AC-AF51-4D4A-B230-EDB739B592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FCD47D-ACB1-4357-A403-885FEB4A37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0A9352-A253-4C51-ACBA-2744A939DA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B957336-1BCD-4222-B55D-DF2C84A47A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BF23BE-991E-4B98-B04E-4A76BB3093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D36D4F4-5674-4F3D-BA87-2C0FA50978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8D52-D88B-414D-B4F2-F08209A96F9E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CC6B630-1B7F-4728-9C8C-85CA83791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2B8936-64A5-4CFB-A00E-0497B8B2C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129E9-23A9-4694-94F4-52B9D8789D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160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4DC04E-6EBB-4EF5-9B75-FDA03627F7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C9F86BC-5EBC-4E51-B24C-7EBA0B1B3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8D52-D88B-414D-B4F2-F08209A96F9E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77F4E7-73A9-4781-86B9-36CCDBECE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8699A5-D5D6-422D-9692-37042381A7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129E9-23A9-4694-94F4-52B9D8789D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1598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9B1D868-A8A0-4B43-A617-248D96E862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8D52-D88B-414D-B4F2-F08209A96F9E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BD59183-3EA9-47CA-9112-64BD138E6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0080E43-4521-45DB-9806-334BA33FC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129E9-23A9-4694-94F4-52B9D8789D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23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39CA99-D77B-4E71-B028-AD990B77F8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301C1F-DDDA-4283-925A-9CAF569F14A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F642737-A599-49CE-9C45-2BE4AAB3FE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D396F0-0085-4D68-8C28-F997524DC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8D52-D88B-414D-B4F2-F08209A96F9E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4DF7C5-B68A-428F-B179-BABA8ECF19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1C1D8A-1626-434E-955E-C6B2F02DE8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129E9-23A9-4694-94F4-52B9D8789D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886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680A0A-DA6D-49D6-8696-C0EFBE4DFE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DE0DD46-0205-455E-9271-DF4C49529F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5743E1-043B-4F8A-B9B3-C47795A9C3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1AE5A2-4703-4D36-B2D1-BF84E1BF4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288D52-D88B-414D-B4F2-F08209A96F9E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99B1AD-B863-4C39-8016-5A5AE7FF5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E6B250-1542-40A9-8361-B97BD76C79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D129E9-23A9-4694-94F4-52B9D8789D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22623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64CF96C-7161-4CCF-9C37-9C0803315A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5FA46A-98DD-4DF7-823D-8CDD120BB9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5D1EED-FDE0-4740-8B3E-8FBD839D7B6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288D52-D88B-414D-B4F2-F08209A96F9E}" type="datetimeFigureOut">
              <a:rPr lang="en-US" smtClean="0"/>
              <a:t>10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888691-74C1-446D-B110-B26EAAE3E1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C1F48D-0D14-4860-98DB-7D810FD9C7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D129E9-23A9-4694-94F4-52B9D8789D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416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doi.org/10.1093/bioinformatics/bty770" TargetMode="Externa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77AF08-D4FB-4AE0-99AD-F7A59147DF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teins identified with only 1 PSM (peptide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91626E2-96E9-422F-8194-495F8B1425D6}"/>
              </a:ext>
            </a:extLst>
          </p:cNvPr>
          <p:cNvSpPr txBox="1"/>
          <p:nvPr/>
        </p:nvSpPr>
        <p:spPr>
          <a:xfrm>
            <a:off x="7700211" y="4251158"/>
            <a:ext cx="376989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sualized using PDV</a:t>
            </a:r>
          </a:p>
          <a:p>
            <a:r>
              <a:rPr lang="en-US" b="0" i="0" dirty="0">
                <a:solidFill>
                  <a:srgbClr val="606C71"/>
                </a:solidFill>
                <a:effectLst/>
                <a:latin typeface="Open Sans" panose="020B0606030504020204" pitchFamily="34" charset="0"/>
              </a:rPr>
              <a:t>Li, K., et al. “PDV: an integrative proteomics data viewer.” Bioinformatics, Volume 35, Issue 7, 01 April 2019, Pages 1249–1251. </a:t>
            </a:r>
            <a:r>
              <a:rPr lang="en-US" b="0" i="0" u="none" strike="noStrike" dirty="0">
                <a:solidFill>
                  <a:srgbClr val="1E6BB8"/>
                </a:solidFill>
                <a:effectLst/>
                <a:latin typeface="Open Sans" panose="020B0606030504020204" pitchFamily="34" charset="0"/>
                <a:hlinkClick r:id="rId2"/>
              </a:rPr>
              <a:t>https://doi.org/10.1093/bioinformatics/bty770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786827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ifitm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6911ED4-DFD2-47B6-8DBD-163BC8AE76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5453" y="787908"/>
            <a:ext cx="10090734" cy="55747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833761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Igfbp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092C6784-02BD-4882-9865-8CB88C0B28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7115" y="732198"/>
            <a:ext cx="10214309" cy="56114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309017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LOC100911485;Mfn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4E0C388-65F4-45F4-B114-B9FA7A5678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3579" y="846134"/>
            <a:ext cx="10037846" cy="54784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14048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Nox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21CB9C2-03A8-4CCB-80C3-249292C87B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3579" y="846134"/>
            <a:ext cx="10037846" cy="54784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90150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Prrc2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A9BF887-33FC-481E-9EF6-C988457DAF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2749" y="729574"/>
            <a:ext cx="10547408" cy="58665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812502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Rpl3I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D629FF4-D5C7-4322-AA0B-CC35B8A7F1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9200" y="791233"/>
            <a:ext cx="10177462" cy="55047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9004727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Sap130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22F9873-4EA7-4BD9-9A94-9195B5F8B4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1494" y="816206"/>
            <a:ext cx="10079455" cy="55274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639757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Serpinf2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561BF98-8445-453F-BD49-4C8D4D6A74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3498" y="844112"/>
            <a:ext cx="9983639" cy="54995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379206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Slc25a5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733B761-862C-4943-8850-6F6A14903B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9621" y="869888"/>
            <a:ext cx="10026566" cy="54404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345223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Txnrd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250A30E-B771-421C-92F2-238C5102AE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5242" y="778864"/>
            <a:ext cx="10180470" cy="55504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57226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 err="1"/>
              <a:t>Ahsp</a:t>
            </a:r>
            <a:endParaRPr lang="en-US" sz="32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F314E0E-E9DC-4FDC-97C9-2C06F6F40A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24000" y="935928"/>
            <a:ext cx="9882187" cy="53886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718925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Wee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1A78D57-EFF6-47A4-A860-BFD903F4A4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8983" y="822121"/>
            <a:ext cx="10156729" cy="54739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65481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Yif1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468FE10-A3C8-4791-80A5-D96D6D606C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5452" y="808235"/>
            <a:ext cx="10114547" cy="55449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448008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F1LWH8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C8CF9E3-5779-4364-BCC0-4E81A76A66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4642" y="756257"/>
            <a:ext cx="10146782" cy="5601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14717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Clock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6ADAB41-F090-4323-BBCC-660D64067A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4323" y="747136"/>
            <a:ext cx="10515834" cy="58490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19745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Cma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54AFC2B-F80E-4AD1-8171-70D0867106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8167" y="965417"/>
            <a:ext cx="9832307" cy="53734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489262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Cog7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CC5ED70-D906-4D74-A70B-2BC20CF143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0863" y="688305"/>
            <a:ext cx="10310562" cy="56458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07430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Cystm1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503D393-ECEB-4C7B-9E0D-3345DDE774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5662" y="834548"/>
            <a:ext cx="10015287" cy="5528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30226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Efemp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67F34DC-D1DF-4D9B-BB5C-7118D86232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79621" y="810201"/>
            <a:ext cx="10017041" cy="55620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89025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Era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A7A34A0-ABD4-4936-B48F-2F8A912FC4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0847" y="751860"/>
            <a:ext cx="10210578" cy="55727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57439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592BBA4-1558-4555-9DCA-54CD20968B4B}"/>
              </a:ext>
            </a:extLst>
          </p:cNvPr>
          <p:cNvSpPr txBox="1"/>
          <p:nvPr/>
        </p:nvSpPr>
        <p:spPr>
          <a:xfrm>
            <a:off x="272716" y="296597"/>
            <a:ext cx="6096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200" dirty="0"/>
              <a:t>Gimap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FF4A3F0-8617-4569-9894-5E5EBF043DB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3157" y="780540"/>
            <a:ext cx="10198267" cy="55202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89050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0</TotalTime>
  <Words>77</Words>
  <Application>Microsoft Office PowerPoint</Application>
  <PresentationFormat>Widescreen</PresentationFormat>
  <Paragraphs>24</Paragraphs>
  <Slides>2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7" baseType="lpstr">
      <vt:lpstr>Arial</vt:lpstr>
      <vt:lpstr>Calibri</vt:lpstr>
      <vt:lpstr>Calibri Light</vt:lpstr>
      <vt:lpstr>Open Sans</vt:lpstr>
      <vt:lpstr>Office Theme</vt:lpstr>
      <vt:lpstr>Proteins identified with only 1 PSM (peptide)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teins identified with only 1 PSM (peptide)</dc:title>
  <dc:creator>Swensen, Adam C</dc:creator>
  <cp:lastModifiedBy>Swensen, Adam C</cp:lastModifiedBy>
  <cp:revision>1</cp:revision>
  <dcterms:created xsi:type="dcterms:W3CDTF">2022-09-30T19:43:19Z</dcterms:created>
  <dcterms:modified xsi:type="dcterms:W3CDTF">2022-10-06T20:38:48Z</dcterms:modified>
</cp:coreProperties>
</file>